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ratheet\Desktop\Divya%202015\lloyd%20lab\20111018%20UCB-11%20to%20-30%20K1-K2-Cyc%202%20(Efficiency%20emthod)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ratheet\Desktop\Divya%202015\lloyd%20lab\jlo%202315\20111019%20UCB-11%20to%20-30%20Eps_Gam_Bet%202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5 (5)'!$W$26:$W$30</c:f>
                <c:numCache>
                  <c:formatCode>General</c:formatCode>
                  <c:ptCount val="5"/>
                  <c:pt idx="0">
                    <c:v>2.30057512E-3</c:v>
                  </c:pt>
                  <c:pt idx="1">
                    <c:v>5.1854038899999998E-3</c:v>
                  </c:pt>
                  <c:pt idx="2">
                    <c:v>6.1845726200000003E-3</c:v>
                  </c:pt>
                  <c:pt idx="3">
                    <c:v>9.4564333400000197E-3</c:v>
                  </c:pt>
                  <c:pt idx="4">
                    <c:v>4.223786720000000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5 (5)'!$U$26:$U$30</c:f>
              <c:numCache>
                <c:formatCode>General</c:formatCode>
                <c:ptCount val="5"/>
                <c:pt idx="0">
                  <c:v>7.2303468308387801E-3</c:v>
                </c:pt>
                <c:pt idx="1">
                  <c:v>2.3958330341460599E-2</c:v>
                </c:pt>
                <c:pt idx="2">
                  <c:v>4.9656299918159501E-2</c:v>
                </c:pt>
                <c:pt idx="3">
                  <c:v>6.3267576573930007E-2</c:v>
                </c:pt>
                <c:pt idx="4">
                  <c:v>0.23144820914302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90644600"/>
        <c:axId val="390641856"/>
      </c:barChart>
      <c:catAx>
        <c:axId val="390644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 w="25400">
            <a:solidFill>
              <a:schemeClr val="tx1"/>
            </a:solidFill>
          </a:ln>
        </c:spPr>
        <c:crossAx val="390641856"/>
        <c:crosses val="autoZero"/>
        <c:auto val="1"/>
        <c:lblAlgn val="ctr"/>
        <c:lblOffset val="100"/>
        <c:noMultiLvlLbl val="0"/>
      </c:catAx>
      <c:valAx>
        <c:axId val="3906418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390644600"/>
        <c:crosses val="autoZero"/>
        <c:crossBetween val="between"/>
        <c:majorUnit val="0.1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6 (5)'!$B$32</c:f>
              <c:strCache>
                <c:ptCount val="1"/>
                <c:pt idx="0">
                  <c:v>γ-Globin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6 (5)'!$E$33:$E$37</c:f>
                <c:numCache>
                  <c:formatCode>General</c:formatCode>
                  <c:ptCount val="5"/>
                  <c:pt idx="0">
                    <c:v>1.2E-2</c:v>
                  </c:pt>
                  <c:pt idx="1">
                    <c:v>6.7699999999999996E-2</c:v>
                  </c:pt>
                  <c:pt idx="2">
                    <c:v>0.17199999999999999</c:v>
                  </c:pt>
                  <c:pt idx="3">
                    <c:v>0.2742</c:v>
                  </c:pt>
                  <c:pt idx="4">
                    <c:v>2.2881999999999998</c:v>
                  </c:pt>
                </c:numCache>
              </c:numRef>
            </c:plus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errBars>
          <c:cat>
            <c:numRef>
              <c:f>'6 (5)'!$A$33:$A$37</c:f>
              <c:numCache>
                <c:formatCode>General</c:formatCode>
                <c:ptCount val="5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</c:numCache>
            </c:numRef>
          </c:cat>
          <c:val>
            <c:numRef>
              <c:f>'6 (5)'!$B$33:$B$37</c:f>
              <c:numCache>
                <c:formatCode>General</c:formatCode>
                <c:ptCount val="5"/>
                <c:pt idx="0">
                  <c:v>4.3400000000000001E-2</c:v>
                </c:pt>
                <c:pt idx="1">
                  <c:v>0.23039999999999999</c:v>
                </c:pt>
                <c:pt idx="2">
                  <c:v>0.89390000000000003</c:v>
                </c:pt>
                <c:pt idx="3">
                  <c:v>2.4359999999999982</c:v>
                </c:pt>
                <c:pt idx="4">
                  <c:v>10.5562</c:v>
                </c:pt>
              </c:numCache>
            </c:numRef>
          </c:val>
        </c:ser>
        <c:ser>
          <c:idx val="1"/>
          <c:order val="1"/>
          <c:tx>
            <c:strRef>
              <c:f>'6 (5)'!$C$32</c:f>
              <c:strCache>
                <c:ptCount val="1"/>
                <c:pt idx="0">
                  <c:v>β-Globin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6 (5)'!$F$33:$F$37</c:f>
                <c:numCache>
                  <c:formatCode>General</c:formatCode>
                  <c:ptCount val="5"/>
                  <c:pt idx="0">
                    <c:v>4.0000000000000001E-3</c:v>
                  </c:pt>
                  <c:pt idx="1">
                    <c:v>4.1000000000000002E-2</c:v>
                  </c:pt>
                  <c:pt idx="2">
                    <c:v>0.1042</c:v>
                  </c:pt>
                  <c:pt idx="3">
                    <c:v>0.37919999999999998</c:v>
                  </c:pt>
                  <c:pt idx="4">
                    <c:v>2.5912000000000002</c:v>
                  </c:pt>
                </c:numCache>
              </c:numRef>
            </c:plus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</c:errBars>
          <c:cat>
            <c:numRef>
              <c:f>'6 (5)'!$A$33:$A$37</c:f>
              <c:numCache>
                <c:formatCode>General</c:formatCode>
                <c:ptCount val="5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</c:numCache>
            </c:numRef>
          </c:cat>
          <c:val>
            <c:numRef>
              <c:f>'6 (5)'!$C$33:$C$37</c:f>
              <c:numCache>
                <c:formatCode>General</c:formatCode>
                <c:ptCount val="5"/>
                <c:pt idx="0">
                  <c:v>3.4500000000000003E-2</c:v>
                </c:pt>
                <c:pt idx="1">
                  <c:v>0.20330000000000001</c:v>
                </c:pt>
                <c:pt idx="2">
                  <c:v>0.68420000000000003</c:v>
                </c:pt>
                <c:pt idx="3">
                  <c:v>2.1757</c:v>
                </c:pt>
                <c:pt idx="4">
                  <c:v>12.9774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90644208"/>
        <c:axId val="363078984"/>
      </c:barChart>
      <c:catAx>
        <c:axId val="3906442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363078984"/>
        <c:crosses val="autoZero"/>
        <c:auto val="1"/>
        <c:lblAlgn val="ctr"/>
        <c:lblOffset val="100"/>
        <c:noMultiLvlLbl val="0"/>
      </c:catAx>
      <c:valAx>
        <c:axId val="3630789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390644208"/>
        <c:crosses val="autoZero"/>
        <c:crossBetween val="between"/>
        <c:majorUnit val="5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78BDD2-117D-4111-A06F-F2F8B1137D45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95388" y="692150"/>
            <a:ext cx="4619625" cy="34639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387136"/>
            <a:ext cx="5608320" cy="415623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9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772669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E0C4B1-694F-49A2-8A07-3F7A7FA048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7840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6"/>
          <p:cNvGrpSpPr/>
          <p:nvPr/>
        </p:nvGrpSpPr>
        <p:grpSpPr>
          <a:xfrm>
            <a:off x="4828403" y="762000"/>
            <a:ext cx="4010797" cy="3276600"/>
            <a:chOff x="1551803" y="1859578"/>
            <a:chExt cx="4010797" cy="3276600"/>
          </a:xfrm>
        </p:grpSpPr>
        <p:sp>
          <p:nvSpPr>
            <p:cNvPr id="8" name="TextBox 7"/>
            <p:cNvSpPr txBox="1"/>
            <p:nvPr/>
          </p:nvSpPr>
          <p:spPr>
            <a:xfrm>
              <a:off x="1600200" y="1859578"/>
              <a:ext cx="381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en-US" b="1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9" name="Chart 8"/>
            <p:cNvGraphicFramePr>
              <a:graphicFrameLocks/>
            </p:cNvGraphicFramePr>
            <p:nvPr/>
          </p:nvGraphicFramePr>
          <p:xfrm>
            <a:off x="1752600" y="2164378"/>
            <a:ext cx="3810000" cy="256002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0" name="TextBox 9"/>
            <p:cNvSpPr txBox="1"/>
            <p:nvPr/>
          </p:nvSpPr>
          <p:spPr>
            <a:xfrm rot="16200000">
              <a:off x="349109" y="3367073"/>
              <a:ext cx="266699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itchFamily="34" charset="0"/>
                  <a:cs typeface="Arial" pitchFamily="34" charset="0"/>
                </a:rPr>
                <a:t>Relative KLF1/</a:t>
              </a:r>
              <a:r>
                <a:rPr lang="en-US" sz="1100" b="1" dirty="0" err="1" smtClean="0">
                  <a:latin typeface="Arial" pitchFamily="34" charset="0"/>
                  <a:cs typeface="Arial" pitchFamily="34" charset="0"/>
                </a:rPr>
                <a:t>Cyclophilin</a:t>
              </a:r>
              <a:r>
                <a:rPr lang="en-US" sz="1100" b="1" dirty="0" smtClean="0">
                  <a:latin typeface="Arial" pitchFamily="34" charset="0"/>
                  <a:cs typeface="Arial" pitchFamily="34" charset="0"/>
                </a:rPr>
                <a:t> A mRNA</a:t>
              </a:r>
              <a:endParaRPr 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739167" y="4828401"/>
              <a:ext cx="19090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Differentiation Day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362200" y="4583668"/>
              <a:ext cx="304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048000" y="4583668"/>
              <a:ext cx="304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657600" y="4583668"/>
              <a:ext cx="304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343400" y="4583668"/>
              <a:ext cx="304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6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953000" y="4583668"/>
              <a:ext cx="304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8</a:t>
              </a:r>
            </a:p>
          </p:txBody>
        </p:sp>
      </p:grpSp>
      <p:grpSp>
        <p:nvGrpSpPr>
          <p:cNvPr id="3" name="Group 16"/>
          <p:cNvGrpSpPr/>
          <p:nvPr/>
        </p:nvGrpSpPr>
        <p:grpSpPr>
          <a:xfrm>
            <a:off x="805190" y="762000"/>
            <a:ext cx="4034304" cy="3276600"/>
            <a:chOff x="2252990" y="1524000"/>
            <a:chExt cx="4034304" cy="3276600"/>
          </a:xfrm>
        </p:grpSpPr>
        <p:grpSp>
          <p:nvGrpSpPr>
            <p:cNvPr id="4" name="Group 11"/>
            <p:cNvGrpSpPr/>
            <p:nvPr/>
          </p:nvGrpSpPr>
          <p:grpSpPr>
            <a:xfrm>
              <a:off x="2252990" y="1524000"/>
              <a:ext cx="4034304" cy="3276600"/>
              <a:chOff x="2252990" y="1524000"/>
              <a:chExt cx="4034304" cy="3276600"/>
            </a:xfrm>
          </p:grpSpPr>
          <p:grpSp>
            <p:nvGrpSpPr>
              <p:cNvPr id="5" name="Group 8"/>
              <p:cNvGrpSpPr/>
              <p:nvPr/>
            </p:nvGrpSpPr>
            <p:grpSpPr>
              <a:xfrm>
                <a:off x="2252990" y="1524000"/>
                <a:ext cx="3233410" cy="3276600"/>
                <a:chOff x="2252990" y="1524000"/>
                <a:chExt cx="3233410" cy="3276600"/>
              </a:xfrm>
            </p:grpSpPr>
            <p:sp>
              <p:nvSpPr>
                <p:cNvPr id="25" name="TextBox 24"/>
                <p:cNvSpPr txBox="1"/>
                <p:nvPr/>
              </p:nvSpPr>
              <p:spPr>
                <a:xfrm>
                  <a:off x="3657600" y="4495800"/>
                  <a:ext cx="1828800" cy="3048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 smtClean="0">
                      <a:latin typeface="Arial" pitchFamily="34" charset="0"/>
                      <a:cs typeface="Arial" pitchFamily="34" charset="0"/>
                    </a:rPr>
                    <a:t>Differentiation Day</a:t>
                  </a:r>
                  <a:endParaRPr lang="en-US" sz="14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 rot="16200000">
                  <a:off x="974840" y="3030750"/>
                  <a:ext cx="281791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 dirty="0" smtClean="0">
                      <a:latin typeface="Arial" pitchFamily="34" charset="0"/>
                      <a:cs typeface="Arial" pitchFamily="34" charset="0"/>
                    </a:rPr>
                    <a:t>Relative globin/</a:t>
                  </a:r>
                  <a:r>
                    <a:rPr lang="en-US" sz="1100" b="1" dirty="0" err="1" smtClean="0">
                      <a:latin typeface="Arial" pitchFamily="34" charset="0"/>
                      <a:cs typeface="Arial" pitchFamily="34" charset="0"/>
                    </a:rPr>
                    <a:t>Cyclophilin</a:t>
                  </a:r>
                  <a:r>
                    <a:rPr lang="en-US" sz="1100" b="1" dirty="0" smtClean="0">
                      <a:latin typeface="Arial" pitchFamily="34" charset="0"/>
                      <a:cs typeface="Arial" pitchFamily="34" charset="0"/>
                    </a:rPr>
                    <a:t> A mRNA</a:t>
                  </a:r>
                  <a:endParaRPr lang="en-US" sz="11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7" name="TextBox 7"/>
                <p:cNvSpPr txBox="1"/>
                <p:nvPr/>
              </p:nvSpPr>
              <p:spPr>
                <a:xfrm>
                  <a:off x="2286000" y="1524000"/>
                  <a:ext cx="381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b="1" dirty="0" smtClean="0">
                      <a:latin typeface="Arial" pitchFamily="34" charset="0"/>
                      <a:cs typeface="Arial" pitchFamily="34" charset="0"/>
                    </a:rPr>
                    <a:t>A</a:t>
                  </a:r>
                  <a:endParaRPr lang="en-US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aphicFrame>
            <p:nvGraphicFramePr>
              <p:cNvPr id="24" name="Chart 23"/>
              <p:cNvGraphicFramePr>
                <a:graphicFrameLocks/>
              </p:cNvGraphicFramePr>
              <p:nvPr/>
            </p:nvGraphicFramePr>
            <p:xfrm>
              <a:off x="2514600" y="1752600"/>
              <a:ext cx="3772694" cy="283527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</p:grpSp>
        <p:grpSp>
          <p:nvGrpSpPr>
            <p:cNvPr id="6" name="Group 15"/>
            <p:cNvGrpSpPr/>
            <p:nvPr/>
          </p:nvGrpSpPr>
          <p:grpSpPr>
            <a:xfrm>
              <a:off x="3200400" y="1905000"/>
              <a:ext cx="1143000" cy="523220"/>
              <a:chOff x="2590800" y="4953000"/>
              <a:chExt cx="1143000" cy="523220"/>
            </a:xfrm>
          </p:grpSpPr>
          <p:sp>
            <p:nvSpPr>
              <p:cNvPr id="20" name="TextBox 19"/>
              <p:cNvSpPr txBox="1"/>
              <p:nvPr/>
            </p:nvSpPr>
            <p:spPr>
              <a:xfrm>
                <a:off x="2743200" y="4953000"/>
                <a:ext cx="99060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g</a:t>
                </a:r>
                <a:r>
                  <a:rPr lang="en-US" sz="1400" b="1" dirty="0" smtClean="0"/>
                  <a:t>-</a:t>
                </a:r>
                <a:r>
                  <a:rPr lang="en-US" sz="1400" b="1" dirty="0" err="1" smtClean="0"/>
                  <a:t>globin</a:t>
                </a:r>
                <a:endParaRPr lang="en-US" sz="1400" b="1" dirty="0" smtClean="0"/>
              </a:p>
              <a:p>
                <a:r>
                  <a:rPr lang="en-US" sz="1400" b="1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b</a:t>
                </a:r>
                <a:r>
                  <a:rPr lang="en-US" sz="1400" b="1" dirty="0" smtClean="0"/>
                  <a:t>-</a:t>
                </a:r>
                <a:r>
                  <a:rPr lang="en-US" sz="1400" b="1" dirty="0" err="1" smtClean="0"/>
                  <a:t>globin</a:t>
                </a:r>
                <a:endParaRPr lang="en-US" sz="1400" b="1" dirty="0"/>
              </a:p>
            </p:txBody>
          </p:sp>
          <p:sp>
            <p:nvSpPr>
              <p:cNvPr id="21" name="Rectangle 20"/>
              <p:cNvSpPr/>
              <p:nvPr/>
            </p:nvSpPr>
            <p:spPr>
              <a:xfrm>
                <a:off x="2590800" y="5029200"/>
                <a:ext cx="137160" cy="13716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2590800" y="5257800"/>
                <a:ext cx="137160" cy="13716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3</TotalTime>
  <Words>21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ivya</dc:creator>
  <cp:lastModifiedBy>Joyce Lloyd</cp:lastModifiedBy>
  <cp:revision>57</cp:revision>
  <cp:lastPrinted>2015-03-09T21:18:51Z</cp:lastPrinted>
  <dcterms:created xsi:type="dcterms:W3CDTF">2015-02-26T10:41:02Z</dcterms:created>
  <dcterms:modified xsi:type="dcterms:W3CDTF">2016-01-07T19:43:22Z</dcterms:modified>
</cp:coreProperties>
</file>